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7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393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040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3786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483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5596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8804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9539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5237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442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1966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165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9686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90750" y="6210299"/>
            <a:ext cx="113411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/>
              <a:t>Figure 4:</a:t>
            </a:r>
            <a:r>
              <a:rPr lang="en-AU" sz="1000" dirty="0"/>
              <a:t> </a:t>
            </a:r>
            <a:r>
              <a:rPr lang="en-AU" sz="1000" b="1" dirty="0"/>
              <a:t>A.</a:t>
            </a:r>
            <a:r>
              <a:rPr lang="en-AU" sz="1000" dirty="0"/>
              <a:t> Comparison of amino acid sequence identities of (1-6) contigs from five shrimp species that matched with arginine kinase (AK) allergen (7-8) known shrimp AK allergen and (9-12) house dust mite and cockroach AK allergen. The sequence identities were calculated using multiple sequence alignment in </a:t>
            </a:r>
            <a:r>
              <a:rPr lang="en-AU" sz="1000" dirty="0" err="1"/>
              <a:t>Clustal</a:t>
            </a:r>
            <a:r>
              <a:rPr lang="en-AU" sz="1000" dirty="0"/>
              <a:t> Omega (EMBL-EBI). </a:t>
            </a:r>
            <a:r>
              <a:rPr lang="en-AU" sz="1000" b="1" dirty="0"/>
              <a:t>B.</a:t>
            </a:r>
            <a:r>
              <a:rPr lang="en-AU" sz="1000" dirty="0"/>
              <a:t> Molecular phylogenetic tree based on published amino acid sequences of Arginine kinase (AK) from edible crustacean and mollusc species; and allergy causing mite and insect species. The branches consist of </a:t>
            </a:r>
            <a:r>
              <a:rPr lang="en-AU" sz="1000" dirty="0" err="1"/>
              <a:t>UniProt</a:t>
            </a:r>
            <a:r>
              <a:rPr lang="en-AU" sz="1000" dirty="0"/>
              <a:t> ID/</a:t>
            </a:r>
            <a:r>
              <a:rPr lang="en-AU" sz="1000" dirty="0" err="1"/>
              <a:t>Genbank</a:t>
            </a:r>
            <a:r>
              <a:rPr lang="en-AU" sz="1000" dirty="0"/>
              <a:t> Accession ID, species name, and followed by common name in brackets. The numbers next to the branches indicate the bootstrap test percentage of 10,000 replicate trees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7704" y="113453"/>
            <a:ext cx="5727192" cy="6156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1493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3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James Cook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ymaviswanathan Karnaneedi</dc:creator>
  <cp:lastModifiedBy>Shaymaviswanathan Karnaneedi</cp:lastModifiedBy>
  <cp:revision>7</cp:revision>
  <dcterms:created xsi:type="dcterms:W3CDTF">2020-11-09T03:01:03Z</dcterms:created>
  <dcterms:modified xsi:type="dcterms:W3CDTF">2020-11-09T03:32:14Z</dcterms:modified>
</cp:coreProperties>
</file>